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8001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5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25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9424"/>
            <a:ext cx="5829300" cy="278553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202378"/>
            <a:ext cx="5143500" cy="19317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45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675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5979"/>
            <a:ext cx="1478756" cy="678047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5979"/>
            <a:ext cx="4350544" cy="678047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5640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627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94696"/>
            <a:ext cx="5915025" cy="332819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54375"/>
            <a:ext cx="5915025" cy="175021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272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29896"/>
            <a:ext cx="2914650" cy="5076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29896"/>
            <a:ext cx="2914650" cy="5076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142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5981"/>
            <a:ext cx="5915025" cy="15464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61357"/>
            <a:ext cx="2901255" cy="9612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22588"/>
            <a:ext cx="2901255" cy="429868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61357"/>
            <a:ext cx="2915543" cy="96123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22588"/>
            <a:ext cx="2915543" cy="429868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638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322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380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400"/>
            <a:ext cx="2211884" cy="18669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51998"/>
            <a:ext cx="3471863" cy="568589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300"/>
            <a:ext cx="2211884" cy="44468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79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3400"/>
            <a:ext cx="2211884" cy="18669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51998"/>
            <a:ext cx="3471863" cy="568589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00300"/>
            <a:ext cx="2211884" cy="444685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164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5981"/>
            <a:ext cx="5915025" cy="15464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29896"/>
            <a:ext cx="5915025" cy="50765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415744"/>
            <a:ext cx="1543050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AFFA00-1C9D-48A2-A589-8EF108ABBDAF}" type="datetimeFigureOut">
              <a:rPr kumimoji="1" lang="ja-JP" altLang="en-US" smtClean="0"/>
              <a:t>2019/7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415744"/>
            <a:ext cx="2314575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415744"/>
            <a:ext cx="1543050" cy="4259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500BE3-1CA3-4B04-BAFF-13086D8BB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211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グループ化 28"/>
          <p:cNvGrpSpPr/>
          <p:nvPr/>
        </p:nvGrpSpPr>
        <p:grpSpPr>
          <a:xfrm>
            <a:off x="278294" y="860563"/>
            <a:ext cx="6256684" cy="6279874"/>
            <a:chOff x="278294" y="491986"/>
            <a:chExt cx="6256684" cy="6279874"/>
          </a:xfrm>
        </p:grpSpPr>
        <p:sp>
          <p:nvSpPr>
            <p:cNvPr id="2" name="正方形/長方形 1"/>
            <p:cNvSpPr/>
            <p:nvPr/>
          </p:nvSpPr>
          <p:spPr>
            <a:xfrm>
              <a:off x="2007703" y="491986"/>
              <a:ext cx="4527275" cy="66592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ssessed for eligibility (n = 20)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4532243" y="1862758"/>
              <a:ext cx="2002735" cy="66592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Excluded (n =</a:t>
              </a:r>
              <a:r>
                <a: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Very high suicide risk (n = 1)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2007704" y="3233530"/>
              <a:ext cx="4527274" cy="91108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kumimoji="1" lang="en-US" altLang="ja-JP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rted CBT (n = 19)</a:t>
              </a:r>
            </a:p>
            <a:p>
              <a:pPr algn="ctr"/>
              <a:r>
                <a:rPr lang="en-US" altLang="ja-JP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leted CBT (n = 19)</a:t>
              </a:r>
            </a:p>
            <a:p>
              <a:pPr algn="ctr"/>
              <a:r>
                <a:rPr kumimoji="1" lang="en-US" altLang="ja-JP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d not complete CBT (n </a:t>
              </a:r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= 0)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2007703" y="5860773"/>
              <a:ext cx="4527275" cy="911087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zed (n = 18)</a:t>
              </a:r>
            </a:p>
            <a:p>
              <a:pPr algn="ctr"/>
              <a:r>
                <a:rPr lang="en-US" altLang="ja-JP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ded from analysis </a:t>
              </a: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(n = 1)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角丸四角形 2"/>
            <p:cNvSpPr/>
            <p:nvPr/>
          </p:nvSpPr>
          <p:spPr>
            <a:xfrm>
              <a:off x="278294" y="611255"/>
              <a:ext cx="1461054" cy="427383"/>
            </a:xfrm>
            <a:prstGeom prst="roundRect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Enrollment</a:t>
              </a:r>
              <a:endParaRPr kumimoji="1" lang="ja-JP" altLang="en-US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角丸四角形 23"/>
            <p:cNvSpPr/>
            <p:nvPr/>
          </p:nvSpPr>
          <p:spPr>
            <a:xfrm>
              <a:off x="278294" y="3475381"/>
              <a:ext cx="1461054" cy="427383"/>
            </a:xfrm>
            <a:prstGeom prst="roundRect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Intervention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角丸四角形 24"/>
            <p:cNvSpPr/>
            <p:nvPr/>
          </p:nvSpPr>
          <p:spPr>
            <a:xfrm>
              <a:off x="278294" y="6102624"/>
              <a:ext cx="1461054" cy="427383"/>
            </a:xfrm>
            <a:prstGeom prst="roundRect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線矢印コネクタ 14"/>
            <p:cNvCxnSpPr>
              <a:stCxn id="22" idx="2"/>
              <a:endCxn id="23" idx="0"/>
            </p:cNvCxnSpPr>
            <p:nvPr/>
          </p:nvCxnSpPr>
          <p:spPr>
            <a:xfrm>
              <a:off x="4271341" y="4144617"/>
              <a:ext cx="0" cy="171615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8" name="グループ化 27"/>
            <p:cNvGrpSpPr/>
            <p:nvPr/>
          </p:nvGrpSpPr>
          <p:grpSpPr>
            <a:xfrm>
              <a:off x="4271340" y="1157908"/>
              <a:ext cx="260903" cy="2075622"/>
              <a:chOff x="4271340" y="1157908"/>
              <a:chExt cx="260903" cy="2075622"/>
            </a:xfrm>
          </p:grpSpPr>
          <p:cxnSp>
            <p:nvCxnSpPr>
              <p:cNvPr id="13" name="直線矢印コネクタ 12"/>
              <p:cNvCxnSpPr>
                <a:stCxn id="2" idx="2"/>
                <a:endCxn id="22" idx="0"/>
              </p:cNvCxnSpPr>
              <p:nvPr/>
            </p:nvCxnSpPr>
            <p:spPr>
              <a:xfrm>
                <a:off x="4271341" y="1157908"/>
                <a:ext cx="0" cy="207562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直線矢印コネクタ 26"/>
              <p:cNvCxnSpPr>
                <a:endCxn id="16" idx="1"/>
              </p:cNvCxnSpPr>
              <p:nvPr/>
            </p:nvCxnSpPr>
            <p:spPr>
              <a:xfrm>
                <a:off x="4271340" y="2195719"/>
                <a:ext cx="260903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139C7041-9950-4F6D-9D87-0089AB9CED38}"/>
              </a:ext>
            </a:extLst>
          </p:cNvPr>
          <p:cNvSpPr/>
          <p:nvPr/>
        </p:nvSpPr>
        <p:spPr>
          <a:xfrm>
            <a:off x="278294" y="7415456"/>
            <a:ext cx="64187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/>
              <a:t>Fig. </a:t>
            </a:r>
            <a:r>
              <a:rPr lang="en-US" altLang="ja-JP" dirty="0" smtClean="0"/>
              <a:t>S1</a:t>
            </a:r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306634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</TotalTime>
  <Words>65</Words>
  <Application>Microsoft Office PowerPoint</Application>
  <PresentationFormat>ユーザー設定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心理</dc:creator>
  <cp:lastModifiedBy>心理</cp:lastModifiedBy>
  <cp:revision>21</cp:revision>
  <dcterms:created xsi:type="dcterms:W3CDTF">2016-11-01T09:03:05Z</dcterms:created>
  <dcterms:modified xsi:type="dcterms:W3CDTF">2019-07-18T02:27:10Z</dcterms:modified>
</cp:coreProperties>
</file>